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1079976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Editor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4" d="100"/>
          <a:sy n="44" d="100"/>
        </p:scale>
        <p:origin x="24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2356703"/>
            <a:ext cx="9179799" cy="5013407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7563446"/>
            <a:ext cx="8099822" cy="3476717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94CF-AB22-4526-8CF3-437E8D7B2B74}" type="datetimeFigureOut">
              <a:rPr lang="ko-KR" altLang="en-US" smtClean="0"/>
              <a:t>2023-10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5DBB-547F-4ACB-BC43-4182D66FE4B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7303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94CF-AB22-4526-8CF3-437E8D7B2B74}" type="datetimeFigureOut">
              <a:rPr lang="ko-KR" altLang="en-US" smtClean="0"/>
              <a:t>2023-10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5DBB-547F-4ACB-BC43-4182D66FE4B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2823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766678"/>
            <a:ext cx="2328699" cy="1220351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766678"/>
            <a:ext cx="6851100" cy="1220351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94CF-AB22-4526-8CF3-437E8D7B2B74}" type="datetimeFigureOut">
              <a:rPr lang="ko-KR" altLang="en-US" smtClean="0"/>
              <a:t>2023-10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5DBB-547F-4ACB-BC43-4182D66FE4B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8587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94CF-AB22-4526-8CF3-437E8D7B2B74}" type="datetimeFigureOut">
              <a:rPr lang="ko-KR" altLang="en-US" smtClean="0"/>
              <a:t>2023-10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5DBB-547F-4ACB-BC43-4182D66FE4B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23010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3590057"/>
            <a:ext cx="9314796" cy="5990088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9636813"/>
            <a:ext cx="9314796" cy="3150046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94CF-AB22-4526-8CF3-437E8D7B2B74}" type="datetimeFigureOut">
              <a:rPr lang="ko-KR" altLang="en-US" smtClean="0"/>
              <a:t>2023-10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5DBB-547F-4ACB-BC43-4182D66FE4B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4115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3833390"/>
            <a:ext cx="4589899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3833390"/>
            <a:ext cx="4589899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94CF-AB22-4526-8CF3-437E8D7B2B74}" type="datetimeFigureOut">
              <a:rPr lang="ko-KR" altLang="en-US" smtClean="0"/>
              <a:t>2023-10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5DBB-547F-4ACB-BC43-4182D66FE4B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0071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766681"/>
            <a:ext cx="9314796" cy="278337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3530053"/>
            <a:ext cx="4568805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5260078"/>
            <a:ext cx="4568805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3530053"/>
            <a:ext cx="4591306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5260078"/>
            <a:ext cx="4591306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94CF-AB22-4526-8CF3-437E8D7B2B74}" type="datetimeFigureOut">
              <a:rPr lang="ko-KR" altLang="en-US" smtClean="0"/>
              <a:t>2023-10-1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5DBB-547F-4ACB-BC43-4182D66FE4B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8120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94CF-AB22-4526-8CF3-437E8D7B2B74}" type="datetimeFigureOut">
              <a:rPr lang="ko-KR" altLang="en-US" smtClean="0"/>
              <a:t>2023-10-1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5DBB-547F-4ACB-BC43-4182D66FE4B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5383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94CF-AB22-4526-8CF3-437E8D7B2B74}" type="datetimeFigureOut">
              <a:rPr lang="ko-KR" altLang="en-US" smtClean="0"/>
              <a:t>2023-10-1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5DBB-547F-4ACB-BC43-4182D66FE4B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4012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2073367"/>
            <a:ext cx="5467380" cy="1023348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94CF-AB22-4526-8CF3-437E8D7B2B74}" type="datetimeFigureOut">
              <a:rPr lang="ko-KR" altLang="en-US" smtClean="0"/>
              <a:t>2023-10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5DBB-547F-4ACB-BC43-4182D66FE4B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2703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2073367"/>
            <a:ext cx="5467380" cy="1023348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D94CF-AB22-4526-8CF3-437E8D7B2B74}" type="datetimeFigureOut">
              <a:rPr lang="ko-KR" altLang="en-US" smtClean="0"/>
              <a:t>2023-10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5DBB-547F-4ACB-BC43-4182D66FE4B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0720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766681"/>
            <a:ext cx="9314796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3833390"/>
            <a:ext cx="9314796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3D94CF-AB22-4526-8CF3-437E8D7B2B74}" type="datetimeFigureOut">
              <a:rPr lang="ko-KR" altLang="en-US" smtClean="0"/>
              <a:t>2023-10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13346867"/>
            <a:ext cx="364492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F75DBB-547F-4ACB-BC43-4182D66FE4B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81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79998" rtl="0" eaLnBrk="1" latinLnBrk="1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1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Box 64">
            <a:extLst>
              <a:ext uri="{FF2B5EF4-FFF2-40B4-BE49-F238E27FC236}">
                <a16:creationId xmlns:a16="http://schemas.microsoft.com/office/drawing/2014/main" id="{F07A339B-C341-4696-BAF8-413304D1EB11}"/>
              </a:ext>
            </a:extLst>
          </p:cNvPr>
          <p:cNvSpPr txBox="1"/>
          <p:nvPr/>
        </p:nvSpPr>
        <p:spPr>
          <a:xfrm>
            <a:off x="649837" y="657225"/>
            <a:ext cx="83322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Table. Survival rate of cell numbers by irradiated UV-C with several optical dosages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표 11">
            <a:extLst>
              <a:ext uri="{FF2B5EF4-FFF2-40B4-BE49-F238E27FC236}">
                <a16:creationId xmlns:a16="http://schemas.microsoft.com/office/drawing/2014/main" id="{E93170CC-96B8-46E4-9515-C28EB15C7E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2771609"/>
              </p:ext>
            </p:extLst>
          </p:nvPr>
        </p:nvGraphicFramePr>
        <p:xfrm>
          <a:off x="716512" y="1158080"/>
          <a:ext cx="8932314" cy="2785270"/>
        </p:xfrm>
        <a:graphic>
          <a:graphicData uri="http://schemas.openxmlformats.org/drawingml/2006/table">
            <a:tbl>
              <a:tblPr/>
              <a:tblGrid>
                <a:gridCol w="1447035">
                  <a:extLst>
                    <a:ext uri="{9D8B030D-6E8A-4147-A177-3AD203B41FA5}">
                      <a16:colId xmlns:a16="http://schemas.microsoft.com/office/drawing/2014/main" val="1301680026"/>
                    </a:ext>
                  </a:extLst>
                </a:gridCol>
                <a:gridCol w="1447035">
                  <a:extLst>
                    <a:ext uri="{9D8B030D-6E8A-4147-A177-3AD203B41FA5}">
                      <a16:colId xmlns:a16="http://schemas.microsoft.com/office/drawing/2014/main" val="2389135555"/>
                    </a:ext>
                  </a:extLst>
                </a:gridCol>
                <a:gridCol w="1214794">
                  <a:extLst>
                    <a:ext uri="{9D8B030D-6E8A-4147-A177-3AD203B41FA5}">
                      <a16:colId xmlns:a16="http://schemas.microsoft.com/office/drawing/2014/main" val="3453122865"/>
                    </a:ext>
                  </a:extLst>
                </a:gridCol>
                <a:gridCol w="964690">
                  <a:extLst>
                    <a:ext uri="{9D8B030D-6E8A-4147-A177-3AD203B41FA5}">
                      <a16:colId xmlns:a16="http://schemas.microsoft.com/office/drawing/2014/main" val="3603604315"/>
                    </a:ext>
                  </a:extLst>
                </a:gridCol>
                <a:gridCol w="771752">
                  <a:extLst>
                    <a:ext uri="{9D8B030D-6E8A-4147-A177-3AD203B41FA5}">
                      <a16:colId xmlns:a16="http://schemas.microsoft.com/office/drawing/2014/main" val="2646176805"/>
                    </a:ext>
                  </a:extLst>
                </a:gridCol>
                <a:gridCol w="771752">
                  <a:extLst>
                    <a:ext uri="{9D8B030D-6E8A-4147-A177-3AD203B41FA5}">
                      <a16:colId xmlns:a16="http://schemas.microsoft.com/office/drawing/2014/main" val="2252103910"/>
                    </a:ext>
                  </a:extLst>
                </a:gridCol>
                <a:gridCol w="771752">
                  <a:extLst>
                    <a:ext uri="{9D8B030D-6E8A-4147-A177-3AD203B41FA5}">
                      <a16:colId xmlns:a16="http://schemas.microsoft.com/office/drawing/2014/main" val="2897124939"/>
                    </a:ext>
                  </a:extLst>
                </a:gridCol>
                <a:gridCol w="771752">
                  <a:extLst>
                    <a:ext uri="{9D8B030D-6E8A-4147-A177-3AD203B41FA5}">
                      <a16:colId xmlns:a16="http://schemas.microsoft.com/office/drawing/2014/main" val="3776088464"/>
                    </a:ext>
                  </a:extLst>
                </a:gridCol>
                <a:gridCol w="771752">
                  <a:extLst>
                    <a:ext uri="{9D8B030D-6E8A-4147-A177-3AD203B41FA5}">
                      <a16:colId xmlns:a16="http://schemas.microsoft.com/office/drawing/2014/main" val="3291397246"/>
                    </a:ext>
                  </a:extLst>
                </a:gridCol>
              </a:tblGrid>
              <a:tr h="278527">
                <a:tc rowSpan="2"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urvival rate of </a:t>
                      </a:r>
                      <a:r>
                        <a:rPr lang="en-US" sz="14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.typhimurium</a:t>
                      </a:r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       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y UV-C ir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istanc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Optical dosage / Exposure time (second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45092067"/>
                  </a:ext>
                </a:extLst>
              </a:tr>
              <a:tr h="278527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982004"/>
                  </a:ext>
                </a:extLst>
              </a:tr>
              <a:tr h="278527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2 n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ell numb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 m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9.E+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9.E+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9.E+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.E+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.E+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.E+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6114121"/>
                  </a:ext>
                </a:extLst>
              </a:tr>
              <a:tr h="27852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duction rat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89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8.39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3.58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0.04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2.27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231476"/>
                  </a:ext>
                </a:extLst>
              </a:tr>
              <a:tr h="27852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ell numb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 m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9.E+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5.E+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.E+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.E+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.E+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0774934"/>
                  </a:ext>
                </a:extLst>
              </a:tr>
              <a:tr h="27852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duction rat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2.61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0.46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96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8.73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6798716"/>
                  </a:ext>
                </a:extLst>
              </a:tr>
              <a:tr h="278527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5 n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ell numb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 m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6.E+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.E+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5.E+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1280796"/>
                  </a:ext>
                </a:extLst>
              </a:tr>
              <a:tr h="27852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duction rat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7.56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85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4006930"/>
                  </a:ext>
                </a:extLst>
              </a:tr>
              <a:tr h="27852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ell numb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 m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6.E+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0.E+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3.E+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563036"/>
                  </a:ext>
                </a:extLst>
              </a:tr>
              <a:tr h="27852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duction rat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86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99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5616631"/>
                  </a:ext>
                </a:extLst>
              </a:tr>
            </a:tbl>
          </a:graphicData>
        </a:graphic>
      </p:graphicFrame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424311AB-3477-4A2A-B5FA-9171C0986C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8952436"/>
              </p:ext>
            </p:extLst>
          </p:nvPr>
        </p:nvGraphicFramePr>
        <p:xfrm>
          <a:off x="716512" y="4105650"/>
          <a:ext cx="8932315" cy="2785270"/>
        </p:xfrm>
        <a:graphic>
          <a:graphicData uri="http://schemas.openxmlformats.org/drawingml/2006/table">
            <a:tbl>
              <a:tblPr/>
              <a:tblGrid>
                <a:gridCol w="1447035">
                  <a:extLst>
                    <a:ext uri="{9D8B030D-6E8A-4147-A177-3AD203B41FA5}">
                      <a16:colId xmlns:a16="http://schemas.microsoft.com/office/drawing/2014/main" val="391827232"/>
                    </a:ext>
                  </a:extLst>
                </a:gridCol>
                <a:gridCol w="1447035">
                  <a:extLst>
                    <a:ext uri="{9D8B030D-6E8A-4147-A177-3AD203B41FA5}">
                      <a16:colId xmlns:a16="http://schemas.microsoft.com/office/drawing/2014/main" val="2647043619"/>
                    </a:ext>
                  </a:extLst>
                </a:gridCol>
                <a:gridCol w="1214795">
                  <a:extLst>
                    <a:ext uri="{9D8B030D-6E8A-4147-A177-3AD203B41FA5}">
                      <a16:colId xmlns:a16="http://schemas.microsoft.com/office/drawing/2014/main" val="2167541337"/>
                    </a:ext>
                  </a:extLst>
                </a:gridCol>
                <a:gridCol w="964690">
                  <a:extLst>
                    <a:ext uri="{9D8B030D-6E8A-4147-A177-3AD203B41FA5}">
                      <a16:colId xmlns:a16="http://schemas.microsoft.com/office/drawing/2014/main" val="2328156265"/>
                    </a:ext>
                  </a:extLst>
                </a:gridCol>
                <a:gridCol w="771752">
                  <a:extLst>
                    <a:ext uri="{9D8B030D-6E8A-4147-A177-3AD203B41FA5}">
                      <a16:colId xmlns:a16="http://schemas.microsoft.com/office/drawing/2014/main" val="1291517534"/>
                    </a:ext>
                  </a:extLst>
                </a:gridCol>
                <a:gridCol w="771752">
                  <a:extLst>
                    <a:ext uri="{9D8B030D-6E8A-4147-A177-3AD203B41FA5}">
                      <a16:colId xmlns:a16="http://schemas.microsoft.com/office/drawing/2014/main" val="1421722569"/>
                    </a:ext>
                  </a:extLst>
                </a:gridCol>
                <a:gridCol w="771752">
                  <a:extLst>
                    <a:ext uri="{9D8B030D-6E8A-4147-A177-3AD203B41FA5}">
                      <a16:colId xmlns:a16="http://schemas.microsoft.com/office/drawing/2014/main" val="416578787"/>
                    </a:ext>
                  </a:extLst>
                </a:gridCol>
                <a:gridCol w="771752">
                  <a:extLst>
                    <a:ext uri="{9D8B030D-6E8A-4147-A177-3AD203B41FA5}">
                      <a16:colId xmlns:a16="http://schemas.microsoft.com/office/drawing/2014/main" val="2405529908"/>
                    </a:ext>
                  </a:extLst>
                </a:gridCol>
                <a:gridCol w="771752">
                  <a:extLst>
                    <a:ext uri="{9D8B030D-6E8A-4147-A177-3AD203B41FA5}">
                      <a16:colId xmlns:a16="http://schemas.microsoft.com/office/drawing/2014/main" val="3971752716"/>
                    </a:ext>
                  </a:extLst>
                </a:gridCol>
              </a:tblGrid>
              <a:tr h="278527">
                <a:tc rowSpan="2"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urvival rate of </a:t>
                      </a:r>
                      <a:r>
                        <a:rPr lang="en-US" sz="14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.aureus</a:t>
                      </a:r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                 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y UV-C irrad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istanc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Optical dosage / Exposure time (second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84463141"/>
                  </a:ext>
                </a:extLst>
              </a:tr>
              <a:tr h="278527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296361"/>
                  </a:ext>
                </a:extLst>
              </a:tr>
              <a:tr h="278527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2 n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ell numb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 m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6.E+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5.E+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.E+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0.E+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7.E+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.E+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3212042"/>
                  </a:ext>
                </a:extLst>
              </a:tr>
              <a:tr h="27852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duction rat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9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3.03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8.60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8.98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95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973344"/>
                  </a:ext>
                </a:extLst>
              </a:tr>
              <a:tr h="27852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ell numb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 m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0.E+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.E+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.E+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7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.E-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8110659"/>
                  </a:ext>
                </a:extLst>
              </a:tr>
              <a:tr h="27852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duction rat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76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76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99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99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5911447"/>
                  </a:ext>
                </a:extLst>
              </a:tr>
              <a:tr h="278527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5 n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ell numb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 m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.E+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6.E+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0.E+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7.E-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0559145"/>
                  </a:ext>
                </a:extLst>
              </a:tr>
              <a:tr h="27852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duction rat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5.8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7.77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9898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996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6612009"/>
                  </a:ext>
                </a:extLst>
              </a:tr>
              <a:tr h="27852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ell numb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 m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5.E+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.E+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3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.E+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6634404"/>
                  </a:ext>
                </a:extLst>
              </a:tr>
              <a:tr h="27852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duction rat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98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99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4681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33989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56</TotalTime>
  <Words>403</Words>
  <Application>Microsoft Office PowerPoint</Application>
  <PresentationFormat>사용자 지정</PresentationFormat>
  <Paragraphs>14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r. KANG</dc:creator>
  <cp:lastModifiedBy>Dr. KANG</cp:lastModifiedBy>
  <cp:revision>31</cp:revision>
  <dcterms:created xsi:type="dcterms:W3CDTF">2023-05-04T04:15:01Z</dcterms:created>
  <dcterms:modified xsi:type="dcterms:W3CDTF">2023-10-17T02:29:15Z</dcterms:modified>
</cp:coreProperties>
</file>